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99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962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83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294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167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788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906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796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241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73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086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349F0-2E99-4CF1-B5AF-20821615AA86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6A73B-1FC1-4143-BDB1-E41FDEFC7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564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085" y="673825"/>
            <a:ext cx="3503198" cy="350319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01430" y="4285235"/>
            <a:ext cx="3166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iControl</a:t>
            </a:r>
            <a:r>
              <a:rPr lang="en-US" dirty="0" smtClean="0"/>
              <a:t> T-cells (original image)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7310" y="673825"/>
            <a:ext cx="3503649" cy="350364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349761" y="4285235"/>
            <a:ext cx="32484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iControl</a:t>
            </a:r>
            <a:r>
              <a:rPr lang="en-US" dirty="0" smtClean="0"/>
              <a:t> T-cells +TG stimulation </a:t>
            </a:r>
          </a:p>
          <a:p>
            <a:r>
              <a:rPr lang="en-US" dirty="0" smtClean="0"/>
              <a:t>(original image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4398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458" y="608895"/>
            <a:ext cx="3606451" cy="36064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01430" y="4285235"/>
            <a:ext cx="2959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iMCU</a:t>
            </a:r>
            <a:r>
              <a:rPr lang="en-US" dirty="0" smtClean="0"/>
              <a:t> T-cells (original image)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1510" y="608894"/>
            <a:ext cx="3606451" cy="360645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900508" y="4285235"/>
            <a:ext cx="30234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iMCU</a:t>
            </a:r>
            <a:r>
              <a:rPr lang="en-US" dirty="0" smtClean="0"/>
              <a:t> T-cells +TG stimulation </a:t>
            </a:r>
          </a:p>
          <a:p>
            <a:r>
              <a:rPr lang="en-US" dirty="0" smtClean="0"/>
              <a:t>(original image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3722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Z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manska, Magdalena /DZNE</dc:creator>
  <cp:lastModifiedBy>Shumanska, Magdalena /DZNE</cp:lastModifiedBy>
  <cp:revision>1</cp:revision>
  <dcterms:created xsi:type="dcterms:W3CDTF">2024-02-19T13:37:44Z</dcterms:created>
  <dcterms:modified xsi:type="dcterms:W3CDTF">2024-02-19T13:38:09Z</dcterms:modified>
</cp:coreProperties>
</file>